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v1.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v1.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 Lesion Area (ORO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9367547806524185"/>
          <c:y val="2.7777777777777776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7727666854143231"/>
          <c:y val="0.13535396617089532"/>
          <c:w val="0.80238493625796781"/>
          <c:h val="0.77926946631671046"/>
        </c:manualLayout>
      </c:layout>
      <c:barChart>
        <c:barDir val="col"/>
        <c:grouping val="clustered"/>
        <c:varyColors val="0"/>
        <c:ser>
          <c:idx val="9"/>
          <c:order val="9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1wk Treatment ORO Plq Area'!$B$17:$D$17</c:f>
                <c:numCache>
                  <c:formatCode>General</c:formatCode>
                  <c:ptCount val="3"/>
                  <c:pt idx="0">
                    <c:v>1660.8345342660316</c:v>
                  </c:pt>
                  <c:pt idx="1">
                    <c:v>1605.9449406502133</c:v>
                  </c:pt>
                  <c:pt idx="2">
                    <c:v>1981.9112696145166</c:v>
                  </c:pt>
                </c:numCache>
              </c:numRef>
            </c:plus>
            <c:minus>
              <c:numRef>
                <c:f>'11wk Treatment ORO Plq Area'!$B$17:$D$17</c:f>
                <c:numCache>
                  <c:formatCode>General</c:formatCode>
                  <c:ptCount val="3"/>
                  <c:pt idx="0">
                    <c:v>1660.8345342660316</c:v>
                  </c:pt>
                  <c:pt idx="1">
                    <c:v>1605.9449406502133</c:v>
                  </c:pt>
                  <c:pt idx="2">
                    <c:v>1981.9112696145166</c:v>
                  </c:pt>
                </c:numCache>
              </c:numRef>
            </c:minus>
          </c:errBars>
          <c:cat>
            <c:numRef>
              <c:f>'11wk Treatment ORO Plq Area'!$B$4:$D$4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11wk Treatment ORO Plq Area'!$B$15:$D$15</c:f>
              <c:numCache>
                <c:formatCode>0.0</c:formatCode>
                <c:ptCount val="3"/>
                <c:pt idx="0">
                  <c:v>36386.946875000001</c:v>
                </c:pt>
                <c:pt idx="1">
                  <c:v>28805.93</c:v>
                </c:pt>
                <c:pt idx="2" formatCode="General">
                  <c:v>17387.424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09408"/>
        <c:axId val="3679142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B$3,'11wk Treatment ORO Plq Area'!$C$4,'11wk Treatment ORO Plq Area'!$D$4)</c:f>
              <c:numCache>
                <c:formatCode>General</c:formatCode>
                <c:ptCount val="3"/>
                <c:pt idx="0" formatCode="0.000">
                  <c:v>1.028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6:$D$6</c:f>
              <c:numCache>
                <c:formatCode>0.0</c:formatCode>
                <c:ptCount val="3"/>
                <c:pt idx="0">
                  <c:v>38184.400000000001</c:v>
                </c:pt>
                <c:pt idx="1">
                  <c:v>25641.5</c:v>
                </c:pt>
                <c:pt idx="2" formatCode="General">
                  <c:v>21861.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B$3,'11wk Treatment ORO Plq Area'!$D$2,'11wk Treatment ORO Plq Area'!$D$4)</c:f>
              <c:numCache>
                <c:formatCode>General</c:formatCode>
                <c:ptCount val="3"/>
                <c:pt idx="0" formatCode="0.000">
                  <c:v>1.028</c:v>
                </c:pt>
                <c:pt idx="1">
                  <c:v>1.968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7:$D$7</c:f>
              <c:numCache>
                <c:formatCode>0.0</c:formatCode>
                <c:ptCount val="3"/>
                <c:pt idx="0">
                  <c:v>32512.799999999999</c:v>
                </c:pt>
                <c:pt idx="1">
                  <c:v>26863.75</c:v>
                </c:pt>
                <c:pt idx="2" formatCode="General">
                  <c:v>18926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A$3,'11wk Treatment ORO Plq Area'!$C$4,'11wk Treatment ORO Plq Area'!$D$4)</c:f>
              <c:numCache>
                <c:formatCode>General</c:formatCode>
                <c:ptCount val="3"/>
                <c:pt idx="0" formatCode="0.000">
                  <c:v>0.96799999999999997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8:$D$8</c:f>
              <c:numCache>
                <c:formatCode>0.0</c:formatCode>
                <c:ptCount val="3"/>
                <c:pt idx="0">
                  <c:v>33757.25</c:v>
                </c:pt>
                <c:pt idx="1">
                  <c:v>34352</c:v>
                </c:pt>
                <c:pt idx="2" formatCode="General">
                  <c:v>16208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A$3,'11wk Treatment ORO Plq Area'!$E$2,'11wk Treatment ORO Plq Area'!$D$4)</c:f>
              <c:numCache>
                <c:formatCode>0.000</c:formatCode>
                <c:ptCount val="3"/>
                <c:pt idx="0">
                  <c:v>0.96799999999999997</c:v>
                </c:pt>
                <c:pt idx="1">
                  <c:v>2.04</c:v>
                </c:pt>
                <c:pt idx="2" formatCode="General">
                  <c:v>3</c:v>
                </c:pt>
              </c:numCache>
            </c:numRef>
          </c:xVal>
          <c:yVal>
            <c:numRef>
              <c:f>'11wk Treatment ORO Plq Area'!$B$9:$D$9</c:f>
              <c:numCache>
                <c:formatCode>0.0</c:formatCode>
                <c:ptCount val="3"/>
                <c:pt idx="0">
                  <c:v>37818.375</c:v>
                </c:pt>
                <c:pt idx="1">
                  <c:v>26723.4</c:v>
                </c:pt>
                <c:pt idx="2" formatCode="General">
                  <c:v>12554.2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1wk Treatment ORO Plq Area'!$B$4:$D$4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10:$D$10</c:f>
              <c:numCache>
                <c:formatCode>0.0</c:formatCode>
                <c:ptCount val="3"/>
                <c:pt idx="0">
                  <c:v>35959.375</c:v>
                </c:pt>
                <c:pt idx="1">
                  <c:v>30449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A$3,'11wk Treatment ORO Plq Area'!$C$4,'11wk Treatment ORO Plq Area'!$D$4)</c:f>
              <c:numCache>
                <c:formatCode>General</c:formatCode>
                <c:ptCount val="3"/>
                <c:pt idx="0" formatCode="0.000">
                  <c:v>0.96799999999999997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11:$D$11</c:f>
              <c:numCache>
                <c:formatCode>General</c:formatCode>
                <c:ptCount val="3"/>
                <c:pt idx="0" formatCode="0.0">
                  <c:v>32171.375</c:v>
                </c:pt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1wk Treatment ORO Plq Area'!$B$3,'11wk Treatment ORO Plq Area'!$C$4,'11wk Treatment ORO Plq Area'!$D$4)</c:f>
              <c:numCache>
                <c:formatCode>General</c:formatCode>
                <c:ptCount val="3"/>
                <c:pt idx="0" formatCode="0.000">
                  <c:v>1.028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12:$D$12</c:f>
              <c:numCache>
                <c:formatCode>General</c:formatCode>
                <c:ptCount val="3"/>
                <c:pt idx="0" formatCode="0.0">
                  <c:v>34102.5</c:v>
                </c:pt>
              </c:numCache>
            </c:numRef>
          </c:yVal>
          <c:smooth val="0"/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1wk Treatment ORO Plq Area'!$B$4:$D$4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13:$D$13</c:f>
              <c:numCache>
                <c:formatCode>General</c:formatCode>
                <c:ptCount val="3"/>
                <c:pt idx="0" formatCode="0.0">
                  <c:v>46589.5</c:v>
                </c:pt>
              </c:numCache>
            </c:numRef>
          </c:yVal>
          <c:smooth val="0"/>
        </c:ser>
        <c:ser>
          <c:idx val="8"/>
          <c:order val="8"/>
          <c:spPr>
            <a:ln w="28575">
              <a:noFill/>
            </a:ln>
          </c:spPr>
          <c:xVal>
            <c:numRef>
              <c:f>'11wk Treatment ORO Plq Area'!$B$4:$D$4</c:f>
              <c:numCache>
                <c:formatCode>General</c:formatCode>
                <c:ptCount val="3"/>
                <c:pt idx="0" formatCode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11wk Treatment ORO Plq Area'!$B$14:$D$14</c:f>
              <c:numCache>
                <c:formatCode>General</c:formatCode>
                <c:ptCount val="3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609408"/>
        <c:axId val="36791424"/>
      </c:scatterChart>
      <c:catAx>
        <c:axId val="36609408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one"/>
        <c:crossAx val="36791424"/>
        <c:crosses val="autoZero"/>
        <c:auto val="1"/>
        <c:lblAlgn val="ctr"/>
        <c:lblOffset val="100"/>
        <c:noMultiLvlLbl val="0"/>
      </c:catAx>
      <c:valAx>
        <c:axId val="367914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 Area (</a:t>
                </a:r>
                <a:r>
                  <a:rPr lang="el-G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928240740740740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6609408"/>
        <c:crosses val="autoZero"/>
        <c:crossBetween val="between"/>
        <c:majorUnit val="1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 Artery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ollage Conten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PS Red)</a:t>
            </a:r>
          </a:p>
        </c:rich>
      </c:tx>
      <c:layout>
        <c:manualLayout>
          <c:xMode val="edge"/>
          <c:yMode val="edge"/>
          <c:x val="0.26561728395061729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445756780402449"/>
          <c:y val="0.16714129483814524"/>
          <c:w val="0.84498687664041994"/>
          <c:h val="0.74928623505395164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S Red Treatment 11wk IA'!$B$14:$D$14</c:f>
                <c:numCache>
                  <c:formatCode>General</c:formatCode>
                  <c:ptCount val="3"/>
                  <c:pt idx="0">
                    <c:v>0.97399260472871163</c:v>
                  </c:pt>
                  <c:pt idx="1">
                    <c:v>1.4890922767662311</c:v>
                  </c:pt>
                  <c:pt idx="2">
                    <c:v>0.3826757530071857</c:v>
                  </c:pt>
                </c:numCache>
              </c:numRef>
            </c:plus>
            <c:minus>
              <c:numRef>
                <c:f>'PS Red Treatment 11wk IA'!$B$14:$D$14</c:f>
                <c:numCache>
                  <c:formatCode>General</c:formatCode>
                  <c:ptCount val="3"/>
                  <c:pt idx="0">
                    <c:v>0.97399260472871163</c:v>
                  </c:pt>
                  <c:pt idx="1">
                    <c:v>1.4890922767662311</c:v>
                  </c:pt>
                  <c:pt idx="2">
                    <c:v>0.3826757530071857</c:v>
                  </c:pt>
                </c:numCache>
              </c:numRef>
            </c:minus>
          </c:errBars>
          <c:cat>
            <c:numRef>
              <c:f>'PS Red Treatment 11wk IA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PS Red Treatment 11wk IA'!$B$12:$D$12</c:f>
              <c:numCache>
                <c:formatCode>0.00</c:formatCode>
                <c:ptCount val="3"/>
                <c:pt idx="0">
                  <c:v>2.0726964029766726</c:v>
                </c:pt>
                <c:pt idx="1">
                  <c:v>3.9460745747367967</c:v>
                </c:pt>
                <c:pt idx="2">
                  <c:v>4.30584857014340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156736"/>
        <c:axId val="37158272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PS Red Treatment 11wk IA'!$B$4,'PS Red Treatment 11wk IA'!$C$4,'PS Red Treatment 11wk IA'!$H$3)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 formatCode="0.000">
                  <c:v>2.968</c:v>
                </c:pt>
              </c:numCache>
            </c:numRef>
          </c:xVal>
          <c:yVal>
            <c:numRef>
              <c:f>'PS Red Treatment 11wk IA'!$B$6:$D$6</c:f>
              <c:numCache>
                <c:formatCode>0.00</c:formatCode>
                <c:ptCount val="3"/>
                <c:pt idx="0">
                  <c:v>4.0151838373623541</c:v>
                </c:pt>
                <c:pt idx="1">
                  <c:v>3.940544357394101</c:v>
                </c:pt>
                <c:pt idx="2">
                  <c:v>4.1961294121172319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PS Red Treatment 11wk IA'!$C$3,'PS Red Treatment 11wk IA'!$E$3,'PS Red Treatment 11wk IA'!$D$4)</c:f>
              <c:numCache>
                <c:formatCode>General</c:formatCode>
                <c:ptCount val="3"/>
                <c:pt idx="0" formatCode="0.000">
                  <c:v>1.028</c:v>
                </c:pt>
                <c:pt idx="1">
                  <c:v>1.968</c:v>
                </c:pt>
                <c:pt idx="2">
                  <c:v>3</c:v>
                </c:pt>
              </c:numCache>
            </c:numRef>
          </c:xVal>
          <c:yVal>
            <c:numRef>
              <c:f>'PS Red Treatment 11wk IA'!$B$7:$D$7</c:f>
              <c:numCache>
                <c:formatCode>0.00</c:formatCode>
                <c:ptCount val="3"/>
                <c:pt idx="0">
                  <c:v>0.97479682275743651</c:v>
                </c:pt>
                <c:pt idx="1">
                  <c:v>2.3027787290918393</c:v>
                </c:pt>
                <c:pt idx="2">
                  <c:v>5.2272375824919468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PS Red Treatment 11wk IA'!$B$3,'PS Red Treatment 11wk IA'!$F$3,'PS Red Treatment 11wk IA'!$D$4)</c:f>
              <c:numCache>
                <c:formatCode>0.000</c:formatCode>
                <c:ptCount val="3"/>
                <c:pt idx="0">
                  <c:v>0.96799999999999997</c:v>
                </c:pt>
                <c:pt idx="1">
                  <c:v>2.028</c:v>
                </c:pt>
                <c:pt idx="2" formatCode="General">
                  <c:v>3</c:v>
                </c:pt>
              </c:numCache>
            </c:numRef>
          </c:xVal>
          <c:yVal>
            <c:numRef>
              <c:f>'PS Red Treatment 11wk IA'!$B$8:$D$8</c:f>
              <c:numCache>
                <c:formatCode>0.00</c:formatCode>
                <c:ptCount val="3"/>
                <c:pt idx="0">
                  <c:v>1.2281085488102259</c:v>
                </c:pt>
                <c:pt idx="1">
                  <c:v>2.5832818655369305</c:v>
                </c:pt>
                <c:pt idx="2">
                  <c:v>3.367618676179862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PS Red Treatment 11wk IA'!$B$4,'PS Red Treatment 11wk IA'!$C$4,'PS Red Treatment 11wk IA'!$I$3)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 formatCode="0.000">
                  <c:v>3.028</c:v>
                </c:pt>
              </c:numCache>
            </c:numRef>
          </c:xVal>
          <c:yVal>
            <c:numRef>
              <c:f>'PS Red Treatment 11wk IA'!$B$9:$D$9</c:f>
              <c:numCache>
                <c:formatCode>0.00</c:formatCode>
                <c:ptCount val="3"/>
                <c:pt idx="1">
                  <c:v>9.650415642986502</c:v>
                </c:pt>
                <c:pt idx="2">
                  <c:v>4.4324086097845976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PS Red Treatment 11wk IA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PS Red Treatment 11wk IA'!$B$10:$D$10</c:f>
              <c:numCache>
                <c:formatCode>0.00</c:formatCode>
                <c:ptCount val="3"/>
                <c:pt idx="1">
                  <c:v>1.2533522786746123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PS Red Treatment 11wk IA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PS Red Treatment 11wk IA'!$B$11:$C$11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156736"/>
        <c:axId val="37158272"/>
      </c:scatterChart>
      <c:catAx>
        <c:axId val="37156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7158272"/>
        <c:crosses val="autoZero"/>
        <c:auto val="1"/>
        <c:lblAlgn val="ctr"/>
        <c:lblOffset val="100"/>
        <c:noMultiLvlLbl val="0"/>
      </c:catAx>
      <c:valAx>
        <c:axId val="37158272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S Red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Positive Area (%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4025663458734325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156736"/>
        <c:crosses val="autoZero"/>
        <c:crossBetween val="between"/>
        <c:majorUnit val="2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 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trix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1798841284864443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028129439943026"/>
          <c:y val="0.13936351706036745"/>
          <c:w val="0.84111639996766652"/>
          <c:h val="0.74465660542432199"/>
        </c:manualLayout>
      </c:layout>
      <c:barChart>
        <c:barDir val="col"/>
        <c:grouping val="clustered"/>
        <c:varyColors val="0"/>
        <c:ser>
          <c:idx val="7"/>
          <c:order val="7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11wks'!$B$31:$D$31</c:f>
                <c:numCache>
                  <c:formatCode>General</c:formatCode>
                  <c:ptCount val="3"/>
                  <c:pt idx="0">
                    <c:v>0.2222222222222224</c:v>
                  </c:pt>
                  <c:pt idx="1">
                    <c:v>0.13944333775567933</c:v>
                  </c:pt>
                  <c:pt idx="2">
                    <c:v>0.1658312395177701</c:v>
                  </c:pt>
                </c:numCache>
              </c:numRef>
            </c:plus>
            <c:minus>
              <c:numRef>
                <c:f>'Movat 11wks'!$B$31:$D$31</c:f>
                <c:numCache>
                  <c:formatCode>General</c:formatCode>
                  <c:ptCount val="3"/>
                  <c:pt idx="0">
                    <c:v>0.2222222222222224</c:v>
                  </c:pt>
                  <c:pt idx="1">
                    <c:v>0.13944333775567933</c:v>
                  </c:pt>
                  <c:pt idx="2">
                    <c:v>0.1658312395177701</c:v>
                  </c:pt>
                </c:numCache>
              </c:numRef>
            </c:minus>
          </c:errBars>
          <c:cat>
            <c:numRef>
              <c:f>'Movat 11wks'!$B$20:$D$20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Movat 11wks'!$B$29:$D$29</c:f>
              <c:numCache>
                <c:formatCode>General</c:formatCode>
                <c:ptCount val="3"/>
                <c:pt idx="0">
                  <c:v>1.2222222222222223</c:v>
                </c:pt>
                <c:pt idx="1">
                  <c:v>1.3333333333333335</c:v>
                </c:pt>
                <c:pt idx="2">
                  <c:v>1.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495360"/>
        <c:axId val="38496896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A$19,'Movat 11wks'!$D$19,'Movat 11wks'!$D$20)</c:f>
              <c:numCache>
                <c:formatCode>General</c:formatCode>
                <c:ptCount val="3"/>
                <c:pt idx="0">
                  <c:v>0.97199999999999998</c:v>
                </c:pt>
                <c:pt idx="1">
                  <c:v>1.972</c:v>
                </c:pt>
                <c:pt idx="2">
                  <c:v>3</c:v>
                </c:pt>
              </c:numCache>
            </c:numRef>
          </c:xVal>
          <c:yVal>
            <c:numRef>
              <c:f>'Movat 11wks'!$B$22:$D$22</c:f>
              <c:numCache>
                <c:formatCode>0.00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.7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19,'Movat 11wks'!$D$19,'Movat 11wks'!$D$20)</c:f>
              <c:numCache>
                <c:formatCode>General</c:formatCode>
                <c:ptCount val="3"/>
                <c:pt idx="0">
                  <c:v>1.028</c:v>
                </c:pt>
                <c:pt idx="1">
                  <c:v>1.972</c:v>
                </c:pt>
                <c:pt idx="2">
                  <c:v>3</c:v>
                </c:pt>
              </c:numCache>
            </c:numRef>
          </c:xVal>
          <c:yVal>
            <c:numRef>
              <c:f>'Movat 11wks'!$B$23:$D$23</c:f>
              <c:numCache>
                <c:formatCode>0.00</c:formatCode>
                <c:ptCount val="3"/>
                <c:pt idx="0">
                  <c:v>1</c:v>
                </c:pt>
                <c:pt idx="1">
                  <c:v>1.5</c:v>
                </c:pt>
                <c:pt idx="2">
                  <c:v>1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20,'Movat 11wks'!$E$19,'Movat 11wks'!$G$19)</c:f>
              <c:numCache>
                <c:formatCode>General</c:formatCode>
                <c:ptCount val="3"/>
                <c:pt idx="0">
                  <c:v>1</c:v>
                </c:pt>
                <c:pt idx="1">
                  <c:v>2.028</c:v>
                </c:pt>
                <c:pt idx="2">
                  <c:v>2.972</c:v>
                </c:pt>
              </c:numCache>
            </c:numRef>
          </c:xVal>
          <c:yVal>
            <c:numRef>
              <c:f>'Movat 11wks'!$B$24:$D$24</c:f>
              <c:numCache>
                <c:formatCode>0.00</c:formatCode>
                <c:ptCount val="3"/>
                <c:pt idx="0">
                  <c:v>1.6666666666666667</c:v>
                </c:pt>
                <c:pt idx="1">
                  <c:v>1.5</c:v>
                </c:pt>
                <c:pt idx="2">
                  <c:v>1.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20,'Movat 11wks'!$C$20,'Movat 11wks'!$H$19)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.028</c:v>
                </c:pt>
              </c:numCache>
            </c:numRef>
          </c:xVal>
          <c:yVal>
            <c:numRef>
              <c:f>'Movat 11wks'!$B$25:$D$25</c:f>
              <c:numCache>
                <c:formatCode>0.00</c:formatCode>
                <c:ptCount val="3"/>
                <c:pt idx="1">
                  <c:v>1.6666666666666667</c:v>
                </c:pt>
                <c:pt idx="2">
                  <c:v>1.5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20,'Movat 11wks'!$E$19,'Movat 11wks'!$D$20)</c:f>
              <c:numCache>
                <c:formatCode>General</c:formatCode>
                <c:ptCount val="3"/>
                <c:pt idx="0">
                  <c:v>1</c:v>
                </c:pt>
                <c:pt idx="1">
                  <c:v>2.028</c:v>
                </c:pt>
                <c:pt idx="2">
                  <c:v>3</c:v>
                </c:pt>
              </c:numCache>
            </c:numRef>
          </c:xVal>
          <c:yVal>
            <c:numRef>
              <c:f>'Movat 11wks'!$B$26:$D$26</c:f>
              <c:numCache>
                <c:formatCode>0.00</c:formatCode>
                <c:ptCount val="3"/>
                <c:pt idx="1">
                  <c:v>1</c:v>
                </c:pt>
                <c:pt idx="2">
                  <c:v>2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11wks'!$B$20:$D$20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27:$D$27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xVal>
            <c:numRef>
              <c:f>'Movat 11wks'!$B$20:$D$20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28:$D$28</c:f>
              <c:numCache>
                <c:formatCode>General</c:formatCode>
                <c:ptCount val="3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495360"/>
        <c:axId val="38496896"/>
      </c:scatterChart>
      <c:catAx>
        <c:axId val="38495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8496896"/>
        <c:crosses val="autoZero"/>
        <c:auto val="1"/>
        <c:lblAlgn val="ctr"/>
        <c:lblOffset val="100"/>
        <c:noMultiLvlLbl val="0"/>
      </c:catAx>
      <c:valAx>
        <c:axId val="384968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7.7071281589819116E-3"/>
              <c:y val="0.2912055263925342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8495360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 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llagen Density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8249999999999997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04320987654321"/>
          <c:y val="0.16714129483814524"/>
          <c:w val="0.84723218625449592"/>
          <c:h val="0.7168788276465442"/>
        </c:manualLayout>
      </c:layout>
      <c:barChart>
        <c:barDir val="col"/>
        <c:grouping val="clustered"/>
        <c:varyColors val="0"/>
        <c:ser>
          <c:idx val="7"/>
          <c:order val="7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11wks'!$B$15:$D$15</c:f>
                <c:numCache>
                  <c:formatCode>General</c:formatCode>
                  <c:ptCount val="3"/>
                  <c:pt idx="0">
                    <c:v>0.36324157862838952</c:v>
                  </c:pt>
                  <c:pt idx="1">
                    <c:v>0.18708286933869744</c:v>
                  </c:pt>
                  <c:pt idx="2">
                    <c:v>0.31224989991991986</c:v>
                  </c:pt>
                </c:numCache>
              </c:numRef>
            </c:plus>
            <c:minus>
              <c:numRef>
                <c:f>'Movat 11wks'!$B$15:$D$15</c:f>
                <c:numCache>
                  <c:formatCode>General</c:formatCode>
                  <c:ptCount val="3"/>
                  <c:pt idx="0">
                    <c:v>0.36324157862838952</c:v>
                  </c:pt>
                  <c:pt idx="1">
                    <c:v>0.18708286933869744</c:v>
                  </c:pt>
                  <c:pt idx="2">
                    <c:v>0.31224989991991986</c:v>
                  </c:pt>
                </c:numCache>
              </c:numRef>
            </c:minus>
          </c:errBars>
          <c:cat>
            <c:numRef>
              <c:f>'Movat 11wks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cat>
          <c:val>
            <c:numRef>
              <c:f>'Movat 11wks'!$B$13:$D$13</c:f>
              <c:numCache>
                <c:formatCode>General</c:formatCode>
                <c:ptCount val="3"/>
                <c:pt idx="0">
                  <c:v>1.5833333333333333</c:v>
                </c:pt>
                <c:pt idx="1">
                  <c:v>2.65</c:v>
                </c:pt>
                <c:pt idx="2">
                  <c:v>2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1093248"/>
        <c:axId val="89223936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1wks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6:$D$6</c:f>
              <c:numCache>
                <c:formatCode>0.00</c:formatCode>
                <c:ptCount val="3"/>
                <c:pt idx="0">
                  <c:v>2.25</c:v>
                </c:pt>
                <c:pt idx="1">
                  <c:v>2.75</c:v>
                </c:pt>
                <c:pt idx="2">
                  <c:v>1.2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4,'Movat 11wks'!$B$3,'Movat 11wks'!$D$4)</c:f>
              <c:numCache>
                <c:formatCode>General</c:formatCode>
                <c:ptCount val="3"/>
                <c:pt idx="0">
                  <c:v>1</c:v>
                </c:pt>
                <c:pt idx="1">
                  <c:v>1.972</c:v>
                </c:pt>
                <c:pt idx="2">
                  <c:v>3</c:v>
                </c:pt>
              </c:numCache>
            </c:numRef>
          </c:xVal>
          <c:yVal>
            <c:numRef>
              <c:f>'Movat 11wks'!$B$7:$D$7</c:f>
              <c:numCache>
                <c:formatCode>0.00</c:formatCode>
                <c:ptCount val="3"/>
                <c:pt idx="0">
                  <c:v>1</c:v>
                </c:pt>
                <c:pt idx="1">
                  <c:v>3</c:v>
                </c:pt>
                <c:pt idx="2">
                  <c:v>2.2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4,'Movat 11wks'!$C$4,'Movat 11wks'!$D$3)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2.972</c:v>
                </c:pt>
              </c:numCache>
            </c:numRef>
          </c:xVal>
          <c:yVal>
            <c:numRef>
              <c:f>'Movat 11wks'!$B$8:$D$8</c:f>
              <c:numCache>
                <c:formatCode>0.00</c:formatCode>
                <c:ptCount val="3"/>
                <c:pt idx="0">
                  <c:v>1.5</c:v>
                </c:pt>
                <c:pt idx="1">
                  <c:v>2</c:v>
                </c:pt>
                <c:pt idx="2">
                  <c:v>2.7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1wks'!$B$4,'Movat 11wks'!$C$3,'Movat 11wks'!$E$3)</c:f>
              <c:numCache>
                <c:formatCode>General</c:formatCode>
                <c:ptCount val="3"/>
                <c:pt idx="0">
                  <c:v>1</c:v>
                </c:pt>
                <c:pt idx="1">
                  <c:v>2.028</c:v>
                </c:pt>
                <c:pt idx="2">
                  <c:v>3.028</c:v>
                </c:pt>
              </c:numCache>
            </c:numRef>
          </c:xVal>
          <c:yVal>
            <c:numRef>
              <c:f>'Movat 11wks'!$B$9:$D$9</c:f>
              <c:numCache>
                <c:formatCode>0.00</c:formatCode>
                <c:ptCount val="3"/>
                <c:pt idx="1">
                  <c:v>3</c:v>
                </c:pt>
                <c:pt idx="2">
                  <c:v>2.75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1wks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10:$D$10</c:f>
              <c:numCache>
                <c:formatCode>0.00</c:formatCode>
                <c:ptCount val="3"/>
                <c:pt idx="1">
                  <c:v>2.5</c:v>
                </c:pt>
                <c:pt idx="2">
                  <c:v>3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11wks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11:$D$11</c:f>
              <c:numCache>
                <c:formatCode>General</c:formatCode>
                <c:ptCount val="3"/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xVal>
            <c:numRef>
              <c:f>'Movat 11wks'!$B$4:$D$4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Movat 11wks'!$B$12:$D$12</c:f>
              <c:numCache>
                <c:formatCode>General</c:formatCode>
                <c:ptCount val="3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093248"/>
        <c:axId val="89223936"/>
      </c:scatterChart>
      <c:catAx>
        <c:axId val="71093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89223936"/>
        <c:crosses val="autoZero"/>
        <c:auto val="1"/>
        <c:lblAlgn val="ctr"/>
        <c:lblOffset val="100"/>
        <c:noMultiLvlLbl val="0"/>
      </c:catAx>
      <c:valAx>
        <c:axId val="892239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91020341207349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1093248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" y="0"/>
            <a:ext cx="8839200" cy="685800"/>
          </a:xfrm>
        </p:spPr>
        <p:txBody>
          <a:bodyPr>
            <a:no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5 Fig (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s  6A and 6B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ovat, ORO, PS Red - Innominate Artery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314036" y="849745"/>
            <a:ext cx="4500418" cy="2908462"/>
            <a:chOff x="228600" y="1143000"/>
            <a:chExt cx="4500418" cy="2908462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93745897"/>
                </p:ext>
              </p:extLst>
            </p:nvPr>
          </p:nvGraphicFramePr>
          <p:xfrm>
            <a:off x="228600" y="1143000"/>
            <a:ext cx="42672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766618" y="3620575"/>
              <a:ext cx="3962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WD + SHS            WD + SHS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Control                  Btk Inhib.          MECA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1241485"/>
              </p:ext>
            </p:extLst>
          </p:nvPr>
        </p:nvGraphicFramePr>
        <p:xfrm>
          <a:off x="4740564" y="838200"/>
          <a:ext cx="4114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9711360"/>
              </p:ext>
            </p:extLst>
          </p:nvPr>
        </p:nvGraphicFramePr>
        <p:xfrm>
          <a:off x="4724400" y="3849893"/>
          <a:ext cx="411956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78057"/>
              </p:ext>
            </p:extLst>
          </p:nvPr>
        </p:nvGraphicFramePr>
        <p:xfrm>
          <a:off x="484909" y="3859518"/>
          <a:ext cx="4114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547254" y="79248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925728" y="79248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18424" y="38862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925728" y="3821668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040028" y="3327318"/>
            <a:ext cx="3962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WD + SHS             WD + SHS             WD + SHS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Control                   Btk Inhib.          MECA:siMMP-9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040028" y="6243896"/>
            <a:ext cx="3962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WD + SHS             WD + SHS             WD + SHS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Control                   Btk Inhib.          MECA:siMMP-9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23479" y="6243895"/>
            <a:ext cx="3962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WD + SHS            WD + SHS             WD + SHS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Control                  Btk Inhib.          MECA:siMMP-9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4860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1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5 Fig (Figs  6A and 6B Movat, ORO, PS Red - Innominate Artery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7</cp:revision>
  <dcterms:created xsi:type="dcterms:W3CDTF">2017-01-26T23:47:11Z</dcterms:created>
  <dcterms:modified xsi:type="dcterms:W3CDTF">2017-01-26T23:59:01Z</dcterms:modified>
</cp:coreProperties>
</file>